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9" r:id="rId3"/>
    <p:sldId id="260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5E500"/>
    <a:srgbClr val="E800E8"/>
    <a:srgbClr val="A4A4A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75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839790-651E-4BDF-8BCF-F4B056F7345A}" type="datetimeFigureOut">
              <a:rPr lang="en-IN" smtClean="0"/>
              <a:t>01-05-2024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2659C9-D19B-4940-BF86-AD101E5F2891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747752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: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ROS1 in complex with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rizotinib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lectinib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, and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idostaurin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t different time intervals. The protein-ligand complexes were fetched from the simulated trajectories at 50 ns, 100 ns, and 200 ns.</a:t>
            </a:r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22659C9-D19B-4940-BF86-AD101E5F2891}" type="slidenum">
              <a:rPr lang="en-IN" smtClean="0"/>
              <a:t>3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506776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25BDC8-7561-54DA-05F5-024838CB73E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34CF9BD-3346-EA4E-8264-00434B87A4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2C380E-295D-F995-BA8B-EC770D7FA2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CA0D7-2A42-416F-BFB4-17106768B0BB}" type="datetimeFigureOut">
              <a:rPr lang="en-IN" smtClean="0"/>
              <a:t>01-05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515E39-96C5-E382-682D-71F81B3399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24AF02-9534-7593-2385-2C69943C66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9B5497-F6AE-4C16-8998-75612E6A2C8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166342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E6C79C-04B8-7E8A-333B-1ECD5E02A8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4F60B9-0707-7020-589C-732AC6DE79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15A6B1-DBBA-A832-4D7E-773A4232E5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CA0D7-2A42-416F-BFB4-17106768B0BB}" type="datetimeFigureOut">
              <a:rPr lang="en-IN" smtClean="0"/>
              <a:t>01-05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DF9060-43E9-4998-83E2-ED52DAEC65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ADB307-ABEF-985C-2DCA-4AB58937B7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9B5497-F6AE-4C16-8998-75612E6A2C8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707700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8127AA9-E1E7-A66A-4445-EBE365ECE2D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DC7D20-B93D-3E9C-6756-EA6E5736BF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B9CE80-A5C1-4711-740B-F7356C3008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CA0D7-2A42-416F-BFB4-17106768B0BB}" type="datetimeFigureOut">
              <a:rPr lang="en-IN" smtClean="0"/>
              <a:t>01-05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064AFF-E404-C019-C7EA-AA4C6404C1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2A838F-11A7-96AB-2DD3-4D5360F263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9B5497-F6AE-4C16-8998-75612E6A2C8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286944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462909-1D3D-827E-039F-5BC262B9DA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654D65-8947-6B20-07C9-F219164CDB4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9A70A0-5820-8138-2A5C-80620919BA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CA0D7-2A42-416F-BFB4-17106768B0BB}" type="datetimeFigureOut">
              <a:rPr lang="en-IN" smtClean="0"/>
              <a:t>01-05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3AC95E-4B18-8C48-51A0-C595EEE931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263964-6066-F923-5D49-64BBD6DEFF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9B5497-F6AE-4C16-8998-75612E6A2C8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72945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5877B3-01B5-360A-5CC8-AECC4B3161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597A01-817C-9417-6571-C05CE9C3F1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A11661-9AEA-E62E-F369-5BD05B9FC4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CA0D7-2A42-416F-BFB4-17106768B0BB}" type="datetimeFigureOut">
              <a:rPr lang="en-IN" smtClean="0"/>
              <a:t>01-05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43B86C-662C-8338-B709-0EBF9C544C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52F898-0F70-2D3A-B501-8E28FBB25B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9B5497-F6AE-4C16-8998-75612E6A2C8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876554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B62511-CE5D-7C3B-BA64-C666D94782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739472-DDD8-01D0-6BAF-C57E4417271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5CD2EF5-F902-2196-E2B1-B3049D5D54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B374C9-2766-8EA0-40EA-E4653FB3CF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CA0D7-2A42-416F-BFB4-17106768B0BB}" type="datetimeFigureOut">
              <a:rPr lang="en-IN" smtClean="0"/>
              <a:t>01-05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68C64D-1F88-3AB4-FAC2-48D3E23EBE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DF7064-8B10-A02F-7F31-12A3C6B7A9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9B5497-F6AE-4C16-8998-75612E6A2C8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210728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4BC7F6-66C5-6BF7-7D6F-3C7C72291E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9EAB6F-8E4D-E5CB-8012-3018B1A7DE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BE9C9D-7F5E-1D21-BFF0-AF28CF5F7F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15E3306-AFD4-DF3E-70B0-523F610A8BA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9EDCBDA-9A16-4899-6AE4-4D314F49990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0685510-ABF3-854F-8E6E-1CD3D78490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CA0D7-2A42-416F-BFB4-17106768B0BB}" type="datetimeFigureOut">
              <a:rPr lang="en-IN" smtClean="0"/>
              <a:t>01-05-2024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954E586-EFA3-DB21-5C56-C091A169B2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007F64C-E6F5-89E8-535E-A258D4B2C1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9B5497-F6AE-4C16-8998-75612E6A2C8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67358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E22D50-CDD6-0A45-6B09-26717949D3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FD4CF32-A1ED-14E2-54ED-0F83FABA2A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CA0D7-2A42-416F-BFB4-17106768B0BB}" type="datetimeFigureOut">
              <a:rPr lang="en-IN" smtClean="0"/>
              <a:t>01-05-2024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3E121EE-055D-E5DE-82B3-09CD1EC2F2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47B0708-BE3C-B25B-8119-BC881F9F40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9B5497-F6AE-4C16-8998-75612E6A2C8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75380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F5DB1F5-D7CB-B215-B837-31AE49FDF8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CA0D7-2A42-416F-BFB4-17106768B0BB}" type="datetimeFigureOut">
              <a:rPr lang="en-IN" smtClean="0"/>
              <a:t>01-05-2024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0EA907F-21E4-C521-F9CB-254484B458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7F1A337-BB6E-6022-1E66-9810C64693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9B5497-F6AE-4C16-8998-75612E6A2C8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823791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63C84D-36E4-E4F5-6878-145E10B088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11C500-89B8-0DC5-C726-E35CA23DEF3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06882D0-5EC7-51E1-FE9D-71F851EA5F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BFEA39-74F5-0DFF-314B-B4C85DCDFC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CA0D7-2A42-416F-BFB4-17106768B0BB}" type="datetimeFigureOut">
              <a:rPr lang="en-IN" smtClean="0"/>
              <a:t>01-05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DB995F-B6DB-36C8-D278-E43FC2D7A4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8077BE-DEAD-8906-9696-C6F53AF85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9B5497-F6AE-4C16-8998-75612E6A2C8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76443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4A7493-C0D6-CBBE-CF57-623E4181E8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354BDCE-694F-00AB-E584-96EA43815F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506EB4-A7B7-169D-B71F-DE3656169D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5B8FF2-28A6-4FEB-87EE-D3F7425B38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CA0D7-2A42-416F-BFB4-17106768B0BB}" type="datetimeFigureOut">
              <a:rPr lang="en-IN" smtClean="0"/>
              <a:t>01-05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0447B4-A763-B088-834B-FE1499DD8D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042D8F-D1C8-8DB5-9F83-E4E885877F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9B5497-F6AE-4C16-8998-75612E6A2C8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32823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11552D2-E8F6-5235-772A-78F5DF1F77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7AF013-ADB2-7019-69D5-C379BFE414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549B18-6CA5-5F63-5AE6-3C9547EB91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CCA0D7-2A42-416F-BFB4-17106768B0BB}" type="datetimeFigureOut">
              <a:rPr lang="en-IN" smtClean="0"/>
              <a:t>01-05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D938D6-8EB8-16AA-B053-1C8EFF8D3E0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3C5372-0A25-356D-D055-56B759C77E7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9B5497-F6AE-4C16-8998-75612E6A2C8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32739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10" Type="http://schemas.openxmlformats.org/officeDocument/2006/relationships/image" Target="../media/image11.png"/><Relationship Id="rId4" Type="http://schemas.openxmlformats.org/officeDocument/2006/relationships/image" Target="../media/image5.png"/><Relationship Id="rId9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7436DC5-790E-5465-6239-9D16FBD45558}"/>
              </a:ext>
            </a:extLst>
          </p:cNvPr>
          <p:cNvSpPr txBox="1"/>
          <p:nvPr/>
        </p:nvSpPr>
        <p:spPr>
          <a:xfrm>
            <a:off x="6096001" y="5960779"/>
            <a:ext cx="609599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: </a:t>
            </a:r>
            <a:r>
              <a:rPr lang="en-IN" sz="1600" dirty="0">
                <a:latin typeface="Arial" panose="020B0604020202020204" pitchFamily="34" charset="0"/>
                <a:cs typeface="Arial" panose="020B0604020202020204" pitchFamily="34" charset="0"/>
              </a:rPr>
              <a:t>ROS1 in complex with co-crystalized (magenta) and docked (yellow) </a:t>
            </a:r>
            <a:r>
              <a:rPr lang="en-IN" sz="1600" dirty="0" err="1">
                <a:latin typeface="Arial" panose="020B0604020202020204" pitchFamily="34" charset="0"/>
                <a:cs typeface="Arial" panose="020B0604020202020204" pitchFamily="34" charset="0"/>
              </a:rPr>
              <a:t>Crizotinib</a:t>
            </a:r>
            <a:r>
              <a:rPr lang="en-IN" sz="1600" dirty="0">
                <a:latin typeface="Arial" panose="020B0604020202020204" pitchFamily="34" charset="0"/>
                <a:cs typeface="Arial" panose="020B0604020202020204" pitchFamily="34" charset="0"/>
              </a:rPr>
              <a:t>. The figure was drawn in </a:t>
            </a:r>
            <a:r>
              <a:rPr lang="en-IN" sz="1600" dirty="0" err="1">
                <a:latin typeface="Arial" panose="020B0604020202020204" pitchFamily="34" charset="0"/>
                <a:cs typeface="Arial" panose="020B0604020202020204" pitchFamily="34" charset="0"/>
              </a:rPr>
              <a:t>PyMOL</a:t>
            </a:r>
            <a:r>
              <a:rPr lang="en-IN" sz="1600" dirty="0">
                <a:latin typeface="Arial" panose="020B0604020202020204" pitchFamily="34" charset="0"/>
                <a:cs typeface="Arial" panose="020B0604020202020204" pitchFamily="34" charset="0"/>
              </a:rPr>
              <a:t> using the PDB coordinates with ID: </a:t>
            </a:r>
            <a:r>
              <a:rPr lang="en-IN" sz="1600" b="0" i="0" dirty="0">
                <a:solidFill>
                  <a:srgbClr val="333333"/>
                </a:solidFill>
                <a:effectLst/>
                <a:highlight>
                  <a:srgbClr val="FFFFFF"/>
                </a:highlight>
                <a:latin typeface="Helvetica Neue"/>
              </a:rPr>
              <a:t>3ZBF</a:t>
            </a:r>
            <a:r>
              <a:rPr lang="en-IN" sz="1600" b="0" i="0" dirty="0">
                <a:solidFill>
                  <a:srgbClr val="333333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IN" sz="1600" b="0" i="0" dirty="0">
              <a:solidFill>
                <a:srgbClr val="333333"/>
              </a:solidFill>
              <a:effectLst/>
              <a:highlight>
                <a:srgbClr val="FFFFFF"/>
              </a:highlight>
              <a:latin typeface="Helvetica Neue"/>
            </a:endParaRP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B2FBEBCF-6C42-4C2D-B81A-4E59CFDA17A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94" t="2824" r="45758" b="7377"/>
          <a:stretch/>
        </p:blipFill>
        <p:spPr>
          <a:xfrm>
            <a:off x="1099129" y="138546"/>
            <a:ext cx="4664364" cy="665323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B368C272-83BC-9531-01A0-F2B9FCC03ED2}"/>
              </a:ext>
            </a:extLst>
          </p:cNvPr>
          <p:cNvSpPr txBox="1"/>
          <p:nvPr/>
        </p:nvSpPr>
        <p:spPr>
          <a:xfrm>
            <a:off x="2483545" y="6106908"/>
            <a:ext cx="25225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>
                <a:solidFill>
                  <a:srgbClr val="A4A4A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S1; PDB ID: 3ZBF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35588196-D8F6-05B4-447F-66A60CD2268E}"/>
              </a:ext>
            </a:extLst>
          </p:cNvPr>
          <p:cNvCxnSpPr>
            <a:cxnSpLocks/>
          </p:cNvCxnSpPr>
          <p:nvPr/>
        </p:nvCxnSpPr>
        <p:spPr>
          <a:xfrm flipH="1">
            <a:off x="3971636" y="1782619"/>
            <a:ext cx="1034473" cy="80356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1FE24AF9-40D9-B3A0-4783-6BA33C14EF56}"/>
              </a:ext>
            </a:extLst>
          </p:cNvPr>
          <p:cNvSpPr txBox="1"/>
          <p:nvPr/>
        </p:nvSpPr>
        <p:spPr>
          <a:xfrm>
            <a:off x="4922981" y="1513250"/>
            <a:ext cx="2576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600" dirty="0">
                <a:solidFill>
                  <a:srgbClr val="E800E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-crystalized </a:t>
            </a:r>
            <a:r>
              <a:rPr lang="en-IN" sz="1600" dirty="0" err="1">
                <a:solidFill>
                  <a:srgbClr val="E800E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izotinib</a:t>
            </a:r>
            <a:endParaRPr lang="en-IN" sz="1600" b="0" i="0" dirty="0">
              <a:solidFill>
                <a:srgbClr val="E800E8"/>
              </a:solidFill>
              <a:effectLst/>
              <a:highlight>
                <a:srgbClr val="FFFFFF"/>
              </a:highlight>
              <a:latin typeface="Helvetica Neue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B682991-5B92-DDED-C291-9EAE5DB5E295}"/>
              </a:ext>
            </a:extLst>
          </p:cNvPr>
          <p:cNvSpPr txBox="1"/>
          <p:nvPr/>
        </p:nvSpPr>
        <p:spPr>
          <a:xfrm>
            <a:off x="4922981" y="1982414"/>
            <a:ext cx="1976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600" dirty="0">
                <a:solidFill>
                  <a:srgbClr val="E5E5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cked </a:t>
            </a:r>
            <a:r>
              <a:rPr lang="en-IN" sz="1600" dirty="0" err="1">
                <a:solidFill>
                  <a:srgbClr val="E5E5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izotinib</a:t>
            </a:r>
            <a:endParaRPr lang="en-IN" sz="1600" b="0" i="0" dirty="0">
              <a:solidFill>
                <a:srgbClr val="E5E500"/>
              </a:solidFill>
              <a:effectLst/>
              <a:highlight>
                <a:srgbClr val="FFFFFF"/>
              </a:highlight>
              <a:latin typeface="Helvetica Neue"/>
            </a:endParaRP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B582F538-9586-9D78-5385-D3F7BEDE7855}"/>
              </a:ext>
            </a:extLst>
          </p:cNvPr>
          <p:cNvCxnSpPr>
            <a:cxnSpLocks/>
          </p:cNvCxnSpPr>
          <p:nvPr/>
        </p:nvCxnSpPr>
        <p:spPr>
          <a:xfrm flipH="1">
            <a:off x="4202545" y="2251783"/>
            <a:ext cx="803564" cy="46916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345336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7436DC5-790E-5465-6239-9D16FBD45558}"/>
              </a:ext>
            </a:extLst>
          </p:cNvPr>
          <p:cNvSpPr txBox="1"/>
          <p:nvPr/>
        </p:nvSpPr>
        <p:spPr>
          <a:xfrm>
            <a:off x="369456" y="5960779"/>
            <a:ext cx="112498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: </a:t>
            </a:r>
            <a:r>
              <a:rPr lang="en-IN" sz="1600" dirty="0">
                <a:latin typeface="Arial" panose="020B0604020202020204" pitchFamily="34" charset="0"/>
                <a:cs typeface="Arial" panose="020B0604020202020204" pitchFamily="34" charset="0"/>
              </a:rPr>
              <a:t>ALK in complex with docked (</a:t>
            </a:r>
            <a:r>
              <a:rPr lang="en-IN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IN" sz="16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IN" sz="1600" dirty="0" err="1">
                <a:latin typeface="Arial" panose="020B0604020202020204" pitchFamily="34" charset="0"/>
                <a:cs typeface="Arial" panose="020B0604020202020204" pitchFamily="34" charset="0"/>
              </a:rPr>
              <a:t>Midostaurin</a:t>
            </a:r>
            <a:r>
              <a:rPr lang="en-IN" sz="1600" dirty="0">
                <a:latin typeface="Arial" panose="020B0604020202020204" pitchFamily="34" charset="0"/>
                <a:cs typeface="Arial" panose="020B0604020202020204" pitchFamily="34" charset="0"/>
              </a:rPr>
              <a:t> and (</a:t>
            </a:r>
            <a:r>
              <a:rPr lang="en-IN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IN" sz="16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IN" sz="1600" dirty="0" err="1">
                <a:latin typeface="Arial" panose="020B0604020202020204" pitchFamily="34" charset="0"/>
                <a:cs typeface="Arial" panose="020B0604020202020204" pitchFamily="34" charset="0"/>
              </a:rPr>
              <a:t>Alectinib</a:t>
            </a:r>
            <a:r>
              <a:rPr lang="en-IN" sz="1600" dirty="0">
                <a:latin typeface="Arial" panose="020B0604020202020204" pitchFamily="34" charset="0"/>
                <a:cs typeface="Arial" panose="020B0604020202020204" pitchFamily="34" charset="0"/>
              </a:rPr>
              <a:t>. The figure was drawn in Discovery Studio Visualizer using the PDB coordinates with ID: </a:t>
            </a:r>
            <a:r>
              <a:rPr lang="en-IN" sz="1600" b="0" i="0" dirty="0">
                <a:solidFill>
                  <a:srgbClr val="333333"/>
                </a:solidFill>
                <a:effectLst/>
                <a:highlight>
                  <a:srgbClr val="FFFFFF"/>
                </a:highlight>
                <a:latin typeface="Helvetica Neue"/>
              </a:rPr>
              <a:t>5FTQ</a:t>
            </a:r>
            <a:r>
              <a:rPr lang="en-IN" sz="1600" b="0" i="0" dirty="0">
                <a:solidFill>
                  <a:srgbClr val="333333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IN" sz="1600" b="0" i="0" dirty="0">
              <a:solidFill>
                <a:srgbClr val="333333"/>
              </a:solidFill>
              <a:effectLst/>
              <a:highlight>
                <a:srgbClr val="FFFFFF"/>
              </a:highlight>
              <a:latin typeface="Helvetica Neue"/>
            </a:endParaRPr>
          </a:p>
        </p:txBody>
      </p:sp>
      <p:pic>
        <p:nvPicPr>
          <p:cNvPr id="4" name="Picture 3" descr="A close-up of a molecule&#10;&#10;Description automatically generated">
            <a:extLst>
              <a:ext uri="{FF2B5EF4-FFF2-40B4-BE49-F238E27FC236}">
                <a16:creationId xmlns:a16="http://schemas.microsoft.com/office/drawing/2014/main" id="{9A6305D4-095A-2C56-F95A-9E51076579C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414" r="38762"/>
          <a:stretch/>
        </p:blipFill>
        <p:spPr>
          <a:xfrm>
            <a:off x="1" y="0"/>
            <a:ext cx="6095999" cy="5389418"/>
          </a:xfrm>
          <a:prstGeom prst="rect">
            <a:avLst/>
          </a:prstGeom>
        </p:spPr>
      </p:pic>
      <p:pic>
        <p:nvPicPr>
          <p:cNvPr id="6" name="Picture 5" descr="A screenshot of a computer&#10;&#10;Description automatically generated">
            <a:extLst>
              <a:ext uri="{FF2B5EF4-FFF2-40B4-BE49-F238E27FC236}">
                <a16:creationId xmlns:a16="http://schemas.microsoft.com/office/drawing/2014/main" id="{393F0756-5B69-6039-CAE9-66F4A1C2DC7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862" r="43093"/>
          <a:stretch/>
        </p:blipFill>
        <p:spPr>
          <a:xfrm>
            <a:off x="5980402" y="0"/>
            <a:ext cx="6146374" cy="538941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ECAD279-98B5-E254-F46B-C7EEC56CB60C}"/>
              </a:ext>
            </a:extLst>
          </p:cNvPr>
          <p:cNvSpPr txBox="1"/>
          <p:nvPr/>
        </p:nvSpPr>
        <p:spPr>
          <a:xfrm>
            <a:off x="0" y="0"/>
            <a:ext cx="6465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2000" b="0" i="0" dirty="0">
              <a:solidFill>
                <a:srgbClr val="333333"/>
              </a:solidFill>
              <a:effectLst/>
              <a:highlight>
                <a:srgbClr val="FFFFFF"/>
              </a:highlight>
              <a:latin typeface="Helvetica Neue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5DAE903-C7B1-4BD0-9E7C-8130483DD186}"/>
              </a:ext>
            </a:extLst>
          </p:cNvPr>
          <p:cNvSpPr txBox="1"/>
          <p:nvPr/>
        </p:nvSpPr>
        <p:spPr>
          <a:xfrm>
            <a:off x="6188364" y="0"/>
            <a:ext cx="6465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2000" b="0" i="0" dirty="0">
              <a:solidFill>
                <a:srgbClr val="333333"/>
              </a:solidFill>
              <a:effectLst/>
              <a:highlight>
                <a:srgbClr val="FFFFFF"/>
              </a:highlight>
              <a:latin typeface="Helvetica Neue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E782B48-4D65-0F7C-4001-FAF3600F5E92}"/>
              </a:ext>
            </a:extLst>
          </p:cNvPr>
          <p:cNvSpPr txBox="1"/>
          <p:nvPr/>
        </p:nvSpPr>
        <p:spPr>
          <a:xfrm>
            <a:off x="1546947" y="4585930"/>
            <a:ext cx="25330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>
                <a:solidFill>
                  <a:schemeClr val="tx1">
                    <a:lumMod val="85000"/>
                    <a:lumOff val="15000"/>
                  </a:schemeClr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−10.2 kcal/mol</a:t>
            </a:r>
            <a:endParaRPr lang="en-IN" dirty="0">
              <a:solidFill>
                <a:schemeClr val="tx1">
                  <a:lumMod val="85000"/>
                  <a:lumOff val="1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610BACA-6C54-2ED5-737C-C9FB99AB8F6E}"/>
              </a:ext>
            </a:extLst>
          </p:cNvPr>
          <p:cNvSpPr txBox="1"/>
          <p:nvPr/>
        </p:nvSpPr>
        <p:spPr>
          <a:xfrm>
            <a:off x="7996382" y="4585930"/>
            <a:ext cx="25330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>
                <a:solidFill>
                  <a:schemeClr val="tx1">
                    <a:lumMod val="85000"/>
                    <a:lumOff val="15000"/>
                  </a:schemeClr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−10.4 kcal/mol</a:t>
            </a:r>
            <a:endParaRPr lang="en-IN" dirty="0">
              <a:solidFill>
                <a:schemeClr val="tx1">
                  <a:lumMod val="85000"/>
                  <a:lumOff val="1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65147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0" name="Group 59">
            <a:extLst>
              <a:ext uri="{FF2B5EF4-FFF2-40B4-BE49-F238E27FC236}">
                <a16:creationId xmlns:a16="http://schemas.microsoft.com/office/drawing/2014/main" id="{57BC946B-C98C-2990-EB94-80B90A15F844}"/>
              </a:ext>
            </a:extLst>
          </p:cNvPr>
          <p:cNvGrpSpPr/>
          <p:nvPr/>
        </p:nvGrpSpPr>
        <p:grpSpPr>
          <a:xfrm>
            <a:off x="-64655" y="-29841"/>
            <a:ext cx="12256655" cy="6917682"/>
            <a:chOff x="-64655" y="-29841"/>
            <a:chExt cx="12256655" cy="6917682"/>
          </a:xfrm>
        </p:grpSpPr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B1826E49-F857-88B9-A9F1-DBBC117B7A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4697" t="19415" r="27959" b="20591"/>
            <a:stretch/>
          </p:blipFill>
          <p:spPr>
            <a:xfrm>
              <a:off x="9051190" y="4759359"/>
              <a:ext cx="3062500" cy="2086878"/>
            </a:xfrm>
            <a:prstGeom prst="rect">
              <a:avLst/>
            </a:prstGeom>
          </p:spPr>
        </p:pic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id="{F566FEA4-3D96-D132-4BAB-7579B6FDE6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4924" t="26297" r="27121" b="15379"/>
            <a:stretch/>
          </p:blipFill>
          <p:spPr>
            <a:xfrm>
              <a:off x="5384804" y="4707876"/>
              <a:ext cx="3293545" cy="2154064"/>
            </a:xfrm>
            <a:prstGeom prst="rect">
              <a:avLst/>
            </a:prstGeom>
          </p:spPr>
        </p:pic>
        <p:pic>
          <p:nvPicPr>
            <p:cNvPr id="51" name="Picture 50">
              <a:extLst>
                <a:ext uri="{FF2B5EF4-FFF2-40B4-BE49-F238E27FC236}">
                  <a16:creationId xmlns:a16="http://schemas.microsoft.com/office/drawing/2014/main" id="{C671680B-4F98-F6D2-4C48-98DC4D04C3A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7273" t="30534" r="53106" b="9692"/>
            <a:stretch/>
          </p:blipFill>
          <p:spPr>
            <a:xfrm>
              <a:off x="2115761" y="4704054"/>
              <a:ext cx="2697019" cy="2146961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BBCF44EA-5E4E-4C38-26F6-9C56AF86BA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758" t="19913" r="41288" b="3991"/>
            <a:stretch/>
          </p:blipFill>
          <p:spPr>
            <a:xfrm>
              <a:off x="1714765" y="0"/>
              <a:ext cx="3434317" cy="2478095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293E06FA-4CC3-2B6E-546A-E1D9EC29D4A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7971" t="27610" r="15103" b="16903"/>
            <a:stretch/>
          </p:blipFill>
          <p:spPr>
            <a:xfrm>
              <a:off x="5159928" y="52561"/>
              <a:ext cx="3542180" cy="2372972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FD26BEAE-93F2-A471-CC5D-1962E66299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-283" t="36133" r="31988" b="11650"/>
            <a:stretch/>
          </p:blipFill>
          <p:spPr>
            <a:xfrm>
              <a:off x="8702108" y="0"/>
              <a:ext cx="3489892" cy="2478095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6C8970C-D6C3-F754-7CC9-E756152E1897}"/>
                </a:ext>
              </a:extLst>
            </p:cNvPr>
            <p:cNvSpPr txBox="1"/>
            <p:nvPr/>
          </p:nvSpPr>
          <p:spPr>
            <a:xfrm>
              <a:off x="0" y="1054381"/>
              <a:ext cx="1745673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400" dirty="0">
                  <a:latin typeface="Arial" panose="020B0604020202020204" pitchFamily="34" charset="0"/>
                  <a:cs typeface="Arial" panose="020B0604020202020204" pitchFamily="34" charset="0"/>
                </a:rPr>
                <a:t>ROS1-Crizotinib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700A51F-BEB1-A7DC-474A-8B7858463F49}"/>
                </a:ext>
              </a:extLst>
            </p:cNvPr>
            <p:cNvSpPr txBox="1"/>
            <p:nvPr/>
          </p:nvSpPr>
          <p:spPr>
            <a:xfrm>
              <a:off x="20830" y="3320102"/>
              <a:ext cx="1714765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400" dirty="0">
                  <a:latin typeface="Arial" panose="020B0604020202020204" pitchFamily="34" charset="0"/>
                  <a:cs typeface="Arial" panose="020B0604020202020204" pitchFamily="34" charset="0"/>
                </a:rPr>
                <a:t>ROS1-Alectinib</a:t>
              </a:r>
            </a:p>
          </p:txBody>
        </p: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3389BC17-7E7B-A90D-F086-B661616AA6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5867" t="38249" r="44171" b="9091"/>
            <a:stretch/>
          </p:blipFill>
          <p:spPr>
            <a:xfrm>
              <a:off x="1714765" y="2478095"/>
              <a:ext cx="3411581" cy="2223214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F6CBC255-939A-87AB-B650-0A4B665604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5700" t="37845" r="44504" b="8956"/>
            <a:stretch/>
          </p:blipFill>
          <p:spPr>
            <a:xfrm>
              <a:off x="5290527" y="2462967"/>
              <a:ext cx="3411581" cy="2253469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67207E63-AC37-23BA-993E-53BF463264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5000" t="31087" r="52652" b="17939"/>
            <a:stretch/>
          </p:blipFill>
          <p:spPr>
            <a:xfrm>
              <a:off x="8783300" y="2425533"/>
              <a:ext cx="3387870" cy="2290903"/>
            </a:xfrm>
            <a:prstGeom prst="rect">
              <a:avLst/>
            </a:prstGeom>
          </p:spPr>
        </p:pic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57D79035-9714-954C-CD88-A489E99C5F93}"/>
                </a:ext>
              </a:extLst>
            </p:cNvPr>
            <p:cNvCxnSpPr>
              <a:cxnSpLocks/>
            </p:cNvCxnSpPr>
            <p:nvPr/>
          </p:nvCxnSpPr>
          <p:spPr>
            <a:xfrm>
              <a:off x="5159928" y="-29841"/>
              <a:ext cx="0" cy="6887841"/>
            </a:xfrm>
            <a:prstGeom prst="line">
              <a:avLst/>
            </a:prstGeom>
            <a:ln w="3175"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F40F7CFD-3D27-8C49-4BB9-8EA0073F1195}"/>
                </a:ext>
              </a:extLst>
            </p:cNvPr>
            <p:cNvCxnSpPr>
              <a:cxnSpLocks/>
            </p:cNvCxnSpPr>
            <p:nvPr/>
          </p:nvCxnSpPr>
          <p:spPr>
            <a:xfrm>
              <a:off x="1676978" y="0"/>
              <a:ext cx="0" cy="6887841"/>
            </a:xfrm>
            <a:prstGeom prst="line">
              <a:avLst/>
            </a:prstGeom>
            <a:ln w="3175"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2EC22DA1-F7DC-8DCB-EFF9-C01C3CBC0BE7}"/>
                </a:ext>
              </a:extLst>
            </p:cNvPr>
            <p:cNvCxnSpPr>
              <a:cxnSpLocks/>
            </p:cNvCxnSpPr>
            <p:nvPr/>
          </p:nvCxnSpPr>
          <p:spPr>
            <a:xfrm>
              <a:off x="8702108" y="0"/>
              <a:ext cx="0" cy="6887841"/>
            </a:xfrm>
            <a:prstGeom prst="line">
              <a:avLst/>
            </a:prstGeom>
            <a:ln w="3175"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7B00B35E-28E0-7EDC-E587-CC3C060E43B1}"/>
                </a:ext>
              </a:extLst>
            </p:cNvPr>
            <p:cNvCxnSpPr>
              <a:cxnSpLocks/>
            </p:cNvCxnSpPr>
            <p:nvPr/>
          </p:nvCxnSpPr>
          <p:spPr>
            <a:xfrm>
              <a:off x="12171170" y="-14921"/>
              <a:ext cx="0" cy="6887841"/>
            </a:xfrm>
            <a:prstGeom prst="line">
              <a:avLst/>
            </a:prstGeom>
            <a:ln w="3175"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82F13F45-0246-F2AA-E420-48C86F6E1EB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-64655" y="2478095"/>
              <a:ext cx="12235825" cy="0"/>
            </a:xfrm>
            <a:prstGeom prst="line">
              <a:avLst/>
            </a:prstGeom>
            <a:ln w="3175"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DABE94D6-E29E-55FA-E130-86896F58778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676978" y="0"/>
              <a:ext cx="10483345" cy="0"/>
            </a:xfrm>
            <a:prstGeom prst="line">
              <a:avLst/>
            </a:prstGeom>
            <a:ln w="3175"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EA0F2479-8A49-3A40-1B54-B7060BCDF00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0" y="4701309"/>
              <a:ext cx="12160323" cy="0"/>
            </a:xfrm>
            <a:prstGeom prst="line">
              <a:avLst/>
            </a:prstGeom>
            <a:ln w="3175"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8F4B2CDE-DB57-C385-8E96-CDA3EFBB998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676978" y="6858000"/>
              <a:ext cx="10483345" cy="0"/>
            </a:xfrm>
            <a:prstGeom prst="line">
              <a:avLst/>
            </a:prstGeom>
            <a:ln w="3175"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03D1DCE4-7B8A-ACA8-C6C3-F633B4504A3A}"/>
                </a:ext>
              </a:extLst>
            </p:cNvPr>
            <p:cNvSpPr txBox="1"/>
            <p:nvPr/>
          </p:nvSpPr>
          <p:spPr>
            <a:xfrm>
              <a:off x="1676977" y="-1"/>
              <a:ext cx="102048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400" dirty="0">
                  <a:latin typeface="Arial" panose="020B0604020202020204" pitchFamily="34" charset="0"/>
                  <a:cs typeface="Arial" panose="020B0604020202020204" pitchFamily="34" charset="0"/>
                </a:rPr>
                <a:t>50 ns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7095F659-003D-2F76-C177-B8BBF828B530}"/>
                </a:ext>
              </a:extLst>
            </p:cNvPr>
            <p:cNvSpPr txBox="1"/>
            <p:nvPr/>
          </p:nvSpPr>
          <p:spPr>
            <a:xfrm>
              <a:off x="1704616" y="2480841"/>
              <a:ext cx="102048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400" dirty="0">
                  <a:latin typeface="Arial" panose="020B0604020202020204" pitchFamily="34" charset="0"/>
                  <a:cs typeface="Arial" panose="020B0604020202020204" pitchFamily="34" charset="0"/>
                </a:rPr>
                <a:t>50 ns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DAB194BA-5AB4-6414-CF88-2EAEFDB931CA}"/>
                </a:ext>
              </a:extLst>
            </p:cNvPr>
            <p:cNvSpPr txBox="1"/>
            <p:nvPr/>
          </p:nvSpPr>
          <p:spPr>
            <a:xfrm>
              <a:off x="1701714" y="4706189"/>
              <a:ext cx="102048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400" dirty="0">
                  <a:latin typeface="Arial" panose="020B0604020202020204" pitchFamily="34" charset="0"/>
                  <a:cs typeface="Arial" panose="020B0604020202020204" pitchFamily="34" charset="0"/>
                </a:rPr>
                <a:t>50 ns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E3FFA7A0-B180-47CC-1CFF-88D56AF75E68}"/>
                </a:ext>
              </a:extLst>
            </p:cNvPr>
            <p:cNvSpPr txBox="1"/>
            <p:nvPr/>
          </p:nvSpPr>
          <p:spPr>
            <a:xfrm>
              <a:off x="5170775" y="4716436"/>
              <a:ext cx="102048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400" dirty="0">
                  <a:latin typeface="Arial" panose="020B0604020202020204" pitchFamily="34" charset="0"/>
                  <a:cs typeface="Arial" panose="020B0604020202020204" pitchFamily="34" charset="0"/>
                </a:rPr>
                <a:t>100 ns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8C9F7332-E394-13D5-0806-2A11D04FBB6E}"/>
                </a:ext>
              </a:extLst>
            </p:cNvPr>
            <p:cNvSpPr txBox="1"/>
            <p:nvPr/>
          </p:nvSpPr>
          <p:spPr>
            <a:xfrm>
              <a:off x="5182664" y="2480841"/>
              <a:ext cx="102048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400" dirty="0">
                  <a:latin typeface="Arial" panose="020B0604020202020204" pitchFamily="34" charset="0"/>
                  <a:cs typeface="Arial" panose="020B0604020202020204" pitchFamily="34" charset="0"/>
                </a:rPr>
                <a:t>100 ns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6A87525E-C6CD-FF4E-324B-754925C856AB}"/>
                </a:ext>
              </a:extLst>
            </p:cNvPr>
            <p:cNvSpPr txBox="1"/>
            <p:nvPr/>
          </p:nvSpPr>
          <p:spPr>
            <a:xfrm>
              <a:off x="5158665" y="15127"/>
              <a:ext cx="102048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400" dirty="0">
                  <a:latin typeface="Arial" panose="020B0604020202020204" pitchFamily="34" charset="0"/>
                  <a:cs typeface="Arial" panose="020B0604020202020204" pitchFamily="34" charset="0"/>
                </a:rPr>
                <a:t>100 ns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51211425-4232-ADA9-AAFE-576671C9C105}"/>
                </a:ext>
              </a:extLst>
            </p:cNvPr>
            <p:cNvSpPr txBox="1"/>
            <p:nvPr/>
          </p:nvSpPr>
          <p:spPr>
            <a:xfrm>
              <a:off x="8712954" y="15127"/>
              <a:ext cx="102048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400" dirty="0">
                  <a:latin typeface="Arial" panose="020B0604020202020204" pitchFamily="34" charset="0"/>
                  <a:cs typeface="Arial" panose="020B0604020202020204" pitchFamily="34" charset="0"/>
                </a:rPr>
                <a:t>200 ns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FECE9B8D-8271-EF51-F347-C0A2F43E360A}"/>
                </a:ext>
              </a:extLst>
            </p:cNvPr>
            <p:cNvSpPr txBox="1"/>
            <p:nvPr/>
          </p:nvSpPr>
          <p:spPr>
            <a:xfrm>
              <a:off x="8704344" y="2462966"/>
              <a:ext cx="102048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400" dirty="0">
                  <a:latin typeface="Arial" panose="020B0604020202020204" pitchFamily="34" charset="0"/>
                  <a:cs typeface="Arial" panose="020B0604020202020204" pitchFamily="34" charset="0"/>
                </a:rPr>
                <a:t>200 ns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E3926B59-BF13-E150-7704-DD68F575B44E}"/>
                </a:ext>
              </a:extLst>
            </p:cNvPr>
            <p:cNvSpPr txBox="1"/>
            <p:nvPr/>
          </p:nvSpPr>
          <p:spPr>
            <a:xfrm>
              <a:off x="8689196" y="4696430"/>
              <a:ext cx="102048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400" dirty="0">
                  <a:latin typeface="Arial" panose="020B0604020202020204" pitchFamily="34" charset="0"/>
                  <a:cs typeface="Arial" panose="020B0604020202020204" pitchFamily="34" charset="0"/>
                </a:rPr>
                <a:t>200 ns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2657610C-B871-EC75-5766-B2922D4548C3}"/>
                </a:ext>
              </a:extLst>
            </p:cNvPr>
            <p:cNvSpPr txBox="1"/>
            <p:nvPr/>
          </p:nvSpPr>
          <p:spPr>
            <a:xfrm>
              <a:off x="-39307" y="5536506"/>
              <a:ext cx="188058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IN" sz="1400" dirty="0">
                  <a:latin typeface="Arial" panose="020B0604020202020204" pitchFamily="34" charset="0"/>
                  <a:cs typeface="Arial" panose="020B0604020202020204" pitchFamily="34" charset="0"/>
                </a:rPr>
                <a:t>ROS1-Midostauri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248710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7</TotalTime>
  <Words>153</Words>
  <Application>Microsoft Office PowerPoint</Application>
  <PresentationFormat>Widescreen</PresentationFormat>
  <Paragraphs>23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Aptos</vt:lpstr>
      <vt:lpstr>Arial</vt:lpstr>
      <vt:lpstr>Calibri</vt:lpstr>
      <vt:lpstr>Calibri Light</vt:lpstr>
      <vt:lpstr>Helvetica Neue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Admin</cp:lastModifiedBy>
  <cp:revision>23</cp:revision>
  <dcterms:created xsi:type="dcterms:W3CDTF">2023-09-06T15:49:55Z</dcterms:created>
  <dcterms:modified xsi:type="dcterms:W3CDTF">2024-05-01T13:32:51Z</dcterms:modified>
</cp:coreProperties>
</file>